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751" r:id="rId2"/>
    <p:sldId id="764" r:id="rId3"/>
    <p:sldId id="766" r:id="rId4"/>
    <p:sldId id="768" r:id="rId5"/>
    <p:sldId id="268" r:id="rId6"/>
  </p:sldIdLst>
  <p:sldSz cx="6858000" cy="9144000" type="screen4x3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B02AE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35" autoAdjust="0"/>
    <p:restoredTop sz="94400" autoAdjust="0"/>
  </p:normalViewPr>
  <p:slideViewPr>
    <p:cSldViewPr snapToGrid="0">
      <p:cViewPr varScale="1">
        <p:scale>
          <a:sx n="83" d="100"/>
          <a:sy n="83" d="100"/>
        </p:scale>
        <p:origin x="3000" y="10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CD4FCFF2-CCEE-4DDB-9ED3-442787E789F7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47EA668E-5513-4FBB-97D6-D4044E30E99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5335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EA668E-5513-4FBB-97D6-D4044E30E993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3045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1324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6553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057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937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9819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9519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992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578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597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1343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826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D0D68C-D478-4D6D-8907-9C90B3A36463}" type="datetimeFigureOut">
              <a:rPr lang="en-US" smtClean="0"/>
              <a:t>8/1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523FDF-4D23-41F2-900D-5C4CE8F140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0093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7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11" Type="http://schemas.openxmlformats.org/officeDocument/2006/relationships/image" Target="../media/image6.tiff"/><Relationship Id="rId5" Type="http://schemas.microsoft.com/office/2007/relationships/hdphoto" Target="../media/hdphoto2.wdp"/><Relationship Id="rId15" Type="http://schemas.openxmlformats.org/officeDocument/2006/relationships/image" Target="../media/image10.png"/><Relationship Id="rId10" Type="http://schemas.microsoft.com/office/2007/relationships/hdphoto" Target="../media/hdphoto4.wdp"/><Relationship Id="rId4" Type="http://schemas.openxmlformats.org/officeDocument/2006/relationships/image" Target="../media/image2.jpeg"/><Relationship Id="rId9" Type="http://schemas.openxmlformats.org/officeDocument/2006/relationships/image" Target="../media/image5.png"/><Relationship Id="rId14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13" Type="http://schemas.openxmlformats.org/officeDocument/2006/relationships/image" Target="../media/image20.png"/><Relationship Id="rId3" Type="http://schemas.openxmlformats.org/officeDocument/2006/relationships/image" Target="../media/image14.tif"/><Relationship Id="rId7" Type="http://schemas.openxmlformats.org/officeDocument/2006/relationships/image" Target="../media/image17.png"/><Relationship Id="rId12" Type="http://schemas.microsoft.com/office/2007/relationships/hdphoto" Target="../media/hdphoto8.wdp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Relationship Id="rId6" Type="http://schemas.microsoft.com/office/2007/relationships/hdphoto" Target="../media/hdphoto5.wdp"/><Relationship Id="rId11" Type="http://schemas.openxmlformats.org/officeDocument/2006/relationships/image" Target="../media/image19.png"/><Relationship Id="rId5" Type="http://schemas.openxmlformats.org/officeDocument/2006/relationships/image" Target="../media/image16.png"/><Relationship Id="rId10" Type="http://schemas.microsoft.com/office/2007/relationships/hdphoto" Target="../media/hdphoto7.wdp"/><Relationship Id="rId4" Type="http://schemas.openxmlformats.org/officeDocument/2006/relationships/image" Target="../media/image15.tif"/><Relationship Id="rId9" Type="http://schemas.openxmlformats.org/officeDocument/2006/relationships/image" Target="../media/image18.png"/><Relationship Id="rId14" Type="http://schemas.microsoft.com/office/2007/relationships/hdphoto" Target="../media/hdphoto9.wdp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microsoft.com/office/2007/relationships/hdphoto" Target="../media/hdphoto15.wdp"/><Relationship Id="rId18" Type="http://schemas.openxmlformats.org/officeDocument/2006/relationships/image" Target="../media/image29.tif"/><Relationship Id="rId3" Type="http://schemas.microsoft.com/office/2007/relationships/hdphoto" Target="../media/hdphoto10.wdp"/><Relationship Id="rId7" Type="http://schemas.microsoft.com/office/2007/relationships/hdphoto" Target="../media/hdphoto12.wdp"/><Relationship Id="rId12" Type="http://schemas.openxmlformats.org/officeDocument/2006/relationships/image" Target="../media/image26.png"/><Relationship Id="rId17" Type="http://schemas.microsoft.com/office/2007/relationships/hdphoto" Target="../media/hdphoto17.wdp"/><Relationship Id="rId2" Type="http://schemas.openxmlformats.org/officeDocument/2006/relationships/image" Target="../media/image21.png"/><Relationship Id="rId16" Type="http://schemas.openxmlformats.org/officeDocument/2006/relationships/image" Target="../media/image2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11" Type="http://schemas.microsoft.com/office/2007/relationships/hdphoto" Target="../media/hdphoto14.wdp"/><Relationship Id="rId5" Type="http://schemas.microsoft.com/office/2007/relationships/hdphoto" Target="../media/hdphoto11.wdp"/><Relationship Id="rId15" Type="http://schemas.microsoft.com/office/2007/relationships/hdphoto" Target="../media/hdphoto16.wdp"/><Relationship Id="rId10" Type="http://schemas.openxmlformats.org/officeDocument/2006/relationships/image" Target="../media/image25.jpeg"/><Relationship Id="rId19" Type="http://schemas.openxmlformats.org/officeDocument/2006/relationships/image" Target="../media/image30.tif"/><Relationship Id="rId4" Type="http://schemas.openxmlformats.org/officeDocument/2006/relationships/image" Target="../media/image22.png"/><Relationship Id="rId9" Type="http://schemas.microsoft.com/office/2007/relationships/hdphoto" Target="../media/hdphoto13.wdp"/><Relationship Id="rId14" Type="http://schemas.openxmlformats.org/officeDocument/2006/relationships/image" Target="../media/image27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5">
            <a:extLst>
              <a:ext uri="{FF2B5EF4-FFF2-40B4-BE49-F238E27FC236}">
                <a16:creationId xmlns:a16="http://schemas.microsoft.com/office/drawing/2014/main" id="{26785F02-53DD-381C-14AD-DC149705AC1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852" t="48599" r="35519" b="34688"/>
          <a:stretch/>
        </p:blipFill>
        <p:spPr bwMode="auto">
          <a:xfrm>
            <a:off x="3213784" y="1174507"/>
            <a:ext cx="1350146" cy="50957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7" name="TextBox 76">
            <a:extLst>
              <a:ext uri="{FF2B5EF4-FFF2-40B4-BE49-F238E27FC236}">
                <a16:creationId xmlns:a16="http://schemas.microsoft.com/office/drawing/2014/main" id="{20C9082D-17BB-B23F-B085-1A3D48ACA4B7}"/>
              </a:ext>
            </a:extLst>
          </p:cNvPr>
          <p:cNvSpPr txBox="1"/>
          <p:nvPr/>
        </p:nvSpPr>
        <p:spPr>
          <a:xfrm>
            <a:off x="1561228" y="85210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C4191465-FF18-E274-ED50-CED64DC22E7C}"/>
              </a:ext>
            </a:extLst>
          </p:cNvPr>
          <p:cNvSpPr txBox="1"/>
          <p:nvPr/>
        </p:nvSpPr>
        <p:spPr>
          <a:xfrm>
            <a:off x="2256438" y="943950"/>
            <a:ext cx="486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356E4BA-F78E-2FB9-D62B-FF19E9AEE601}"/>
              </a:ext>
            </a:extLst>
          </p:cNvPr>
          <p:cNvSpPr txBox="1"/>
          <p:nvPr/>
        </p:nvSpPr>
        <p:spPr>
          <a:xfrm>
            <a:off x="3560377" y="926004"/>
            <a:ext cx="9049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pic>
        <p:nvPicPr>
          <p:cNvPr id="80" name="Picture 5">
            <a:extLst>
              <a:ext uri="{FF2B5EF4-FFF2-40B4-BE49-F238E27FC236}">
                <a16:creationId xmlns:a16="http://schemas.microsoft.com/office/drawing/2014/main" id="{9DA73EE9-3167-C815-67B3-00D900DA7B93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3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070" t="1353" r="35493" b="81772"/>
          <a:stretch/>
        </p:blipFill>
        <p:spPr bwMode="auto">
          <a:xfrm>
            <a:off x="1784091" y="1151146"/>
            <a:ext cx="1405088" cy="542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F3022412-38F0-8C67-1A66-F60F1068151E}"/>
              </a:ext>
            </a:extLst>
          </p:cNvPr>
          <p:cNvCxnSpPr/>
          <p:nvPr/>
        </p:nvCxnSpPr>
        <p:spPr>
          <a:xfrm flipH="1">
            <a:off x="3926328" y="1691275"/>
            <a:ext cx="4539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A9870E81-0133-2D87-7EBB-9C82293D4258}"/>
              </a:ext>
            </a:extLst>
          </p:cNvPr>
          <p:cNvSpPr txBox="1"/>
          <p:nvPr/>
        </p:nvSpPr>
        <p:spPr>
          <a:xfrm rot="16200000">
            <a:off x="1490242" y="2128690"/>
            <a:ext cx="636626" cy="239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trium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A9870E81-0133-2D87-7EBB-9C82293D4258}"/>
              </a:ext>
            </a:extLst>
          </p:cNvPr>
          <p:cNvSpPr txBox="1"/>
          <p:nvPr/>
        </p:nvSpPr>
        <p:spPr>
          <a:xfrm rot="16200000">
            <a:off x="1403588" y="2908374"/>
            <a:ext cx="8219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entricle</a:t>
            </a:r>
          </a:p>
        </p:txBody>
      </p:sp>
      <p:pic>
        <p:nvPicPr>
          <p:cNvPr id="85" name="Picture 3">
            <a:extLst>
              <a:ext uri="{FF2B5EF4-FFF2-40B4-BE49-F238E27FC236}">
                <a16:creationId xmlns:a16="http://schemas.microsoft.com/office/drawing/2014/main" id="{8DDBF3B8-7909-4665-81DA-3E188F03EE5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94" t="41054" r="18146" b="50040"/>
          <a:stretch/>
        </p:blipFill>
        <p:spPr bwMode="auto">
          <a:xfrm>
            <a:off x="3320549" y="2678938"/>
            <a:ext cx="1324858" cy="7897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6" name="Picture 3">
            <a:extLst>
              <a:ext uri="{FF2B5EF4-FFF2-40B4-BE49-F238E27FC236}">
                <a16:creationId xmlns:a16="http://schemas.microsoft.com/office/drawing/2014/main" id="{2C842B5E-2412-6EA4-A20F-5D3BB71F3F6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11000" contrast="1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304" t="18172" r="53660" b="73594"/>
          <a:stretch/>
        </p:blipFill>
        <p:spPr bwMode="auto">
          <a:xfrm>
            <a:off x="3323280" y="1867436"/>
            <a:ext cx="1322127" cy="78261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0C958CFB-017C-2601-F035-CF59DAF6A03A}"/>
              </a:ext>
            </a:extLst>
          </p:cNvPr>
          <p:cNvCxnSpPr/>
          <p:nvPr/>
        </p:nvCxnSpPr>
        <p:spPr>
          <a:xfrm flipH="1" flipV="1">
            <a:off x="3593331" y="2149501"/>
            <a:ext cx="90129" cy="1130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2EC22B64-8B5F-1E98-3712-DC707FF36895}"/>
              </a:ext>
            </a:extLst>
          </p:cNvPr>
          <p:cNvCxnSpPr/>
          <p:nvPr/>
        </p:nvCxnSpPr>
        <p:spPr>
          <a:xfrm flipH="1" flipV="1">
            <a:off x="4374161" y="2399157"/>
            <a:ext cx="90129" cy="1130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9" name="Picture 2">
            <a:extLst>
              <a:ext uri="{FF2B5EF4-FFF2-40B4-BE49-F238E27FC236}">
                <a16:creationId xmlns:a16="http://schemas.microsoft.com/office/drawing/2014/main" id="{5A7728B0-C293-7A4B-81F4-80FB5FA8102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12000" contrast="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0371" t="50685" r="69493" b="40975"/>
          <a:stretch/>
        </p:blipFill>
        <p:spPr bwMode="auto">
          <a:xfrm>
            <a:off x="1961282" y="1867522"/>
            <a:ext cx="1321691" cy="7825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F9516BDD-7B84-E2F5-78A0-D72D1172FD88}"/>
              </a:ext>
            </a:extLst>
          </p:cNvPr>
          <p:cNvCxnSpPr/>
          <p:nvPr/>
        </p:nvCxnSpPr>
        <p:spPr>
          <a:xfrm>
            <a:off x="4145176" y="3383858"/>
            <a:ext cx="4538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1" name="Picture 4">
            <a:extLst>
              <a:ext uri="{FF2B5EF4-FFF2-40B4-BE49-F238E27FC236}">
                <a16:creationId xmlns:a16="http://schemas.microsoft.com/office/drawing/2014/main" id="{345C930A-EFD1-487F-A45D-477C2D38EE6A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820" t="51691" r="8577" b="39486"/>
          <a:stretch/>
        </p:blipFill>
        <p:spPr bwMode="auto">
          <a:xfrm>
            <a:off x="1953061" y="2678938"/>
            <a:ext cx="1329913" cy="78252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BF03EA57-87C9-4327-B8D6-F16D0E3DB015}"/>
              </a:ext>
            </a:extLst>
          </p:cNvPr>
          <p:cNvCxnSpPr/>
          <p:nvPr/>
        </p:nvCxnSpPr>
        <p:spPr>
          <a:xfrm flipH="1" flipV="1">
            <a:off x="4068088" y="3063276"/>
            <a:ext cx="69541" cy="12157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2EC22B64-8B5F-1E98-3712-DC707FF36895}"/>
              </a:ext>
            </a:extLst>
          </p:cNvPr>
          <p:cNvCxnSpPr/>
          <p:nvPr/>
        </p:nvCxnSpPr>
        <p:spPr>
          <a:xfrm flipH="1" flipV="1">
            <a:off x="3388309" y="2476664"/>
            <a:ext cx="90129" cy="1130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2EC22B64-8B5F-1E98-3712-DC707FF36895}"/>
              </a:ext>
            </a:extLst>
          </p:cNvPr>
          <p:cNvCxnSpPr/>
          <p:nvPr/>
        </p:nvCxnSpPr>
        <p:spPr>
          <a:xfrm flipH="1">
            <a:off x="3393841" y="2388407"/>
            <a:ext cx="178004" cy="3989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2EC22B64-8B5F-1E98-3712-DC707FF36895}"/>
              </a:ext>
            </a:extLst>
          </p:cNvPr>
          <p:cNvCxnSpPr/>
          <p:nvPr/>
        </p:nvCxnSpPr>
        <p:spPr>
          <a:xfrm flipV="1">
            <a:off x="4432351" y="2141905"/>
            <a:ext cx="2270" cy="15742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2EC22B64-8B5F-1E98-3712-DC707FF36895}"/>
              </a:ext>
            </a:extLst>
          </p:cNvPr>
          <p:cNvCxnSpPr/>
          <p:nvPr/>
        </p:nvCxnSpPr>
        <p:spPr>
          <a:xfrm flipH="1" flipV="1">
            <a:off x="4517402" y="2157511"/>
            <a:ext cx="90129" cy="11305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>
            <a:extLst>
              <a:ext uri="{FF2B5EF4-FFF2-40B4-BE49-F238E27FC236}">
                <a16:creationId xmlns:a16="http://schemas.microsoft.com/office/drawing/2014/main" id="{20C9082D-17BB-B23F-B085-1A3D48ACA4B7}"/>
              </a:ext>
            </a:extLst>
          </p:cNvPr>
          <p:cNvSpPr txBox="1"/>
          <p:nvPr/>
        </p:nvSpPr>
        <p:spPr>
          <a:xfrm>
            <a:off x="1561228" y="163396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739" t="13448" r="4043" b="29199"/>
          <a:stretch/>
        </p:blipFill>
        <p:spPr bwMode="auto">
          <a:xfrm>
            <a:off x="2227786" y="3943409"/>
            <a:ext cx="1175100" cy="12138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69" t="15293" r="4601" b="29536"/>
          <a:stretch/>
        </p:blipFill>
        <p:spPr bwMode="auto">
          <a:xfrm>
            <a:off x="3409244" y="3961788"/>
            <a:ext cx="1244043" cy="11875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55" t="13877" r="4720" b="30041"/>
          <a:stretch/>
        </p:blipFill>
        <p:spPr bwMode="auto">
          <a:xfrm>
            <a:off x="4794258" y="3929983"/>
            <a:ext cx="1275571" cy="12114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5272011" y="3608971"/>
            <a:ext cx="5757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mmp2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898577" y="3608971"/>
            <a:ext cx="3738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l-6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722042" y="3608971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il-1b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014491" y="5076965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383727" y="5076965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179804" y="3833673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48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672446" y="3833673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05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861574" y="3833673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0.00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637191" y="5055699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4038326" y="5055699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2418294" y="5066332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2798164" y="5055699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pic>
        <p:nvPicPr>
          <p:cNvPr id="55" name="Picture 4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12" t="14116" r="4546" b="29441"/>
          <a:stretch/>
        </p:blipFill>
        <p:spPr bwMode="auto">
          <a:xfrm>
            <a:off x="994742" y="3943410"/>
            <a:ext cx="1097001" cy="12059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9" name="TextBox 58"/>
          <p:cNvSpPr txBox="1"/>
          <p:nvPr/>
        </p:nvSpPr>
        <p:spPr>
          <a:xfrm>
            <a:off x="1148509" y="5066332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1511746" y="5055699"/>
            <a:ext cx="7360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1523264" y="3608971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1338198" y="3833673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01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20C9082D-17BB-B23F-B085-1A3D48ACA4B7}"/>
              </a:ext>
            </a:extLst>
          </p:cNvPr>
          <p:cNvSpPr txBox="1"/>
          <p:nvPr/>
        </p:nvSpPr>
        <p:spPr>
          <a:xfrm>
            <a:off x="671057" y="354912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20C9082D-17BB-B23F-B085-1A3D48ACA4B7}"/>
              </a:ext>
            </a:extLst>
          </p:cNvPr>
          <p:cNvSpPr txBox="1"/>
          <p:nvPr/>
        </p:nvSpPr>
        <p:spPr>
          <a:xfrm>
            <a:off x="2157628" y="354912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20C9082D-17BB-B23F-B085-1A3D48ACA4B7}"/>
              </a:ext>
            </a:extLst>
          </p:cNvPr>
          <p:cNvSpPr txBox="1"/>
          <p:nvPr/>
        </p:nvSpPr>
        <p:spPr>
          <a:xfrm>
            <a:off x="3558690" y="354912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20C9082D-17BB-B23F-B085-1A3D48ACA4B7}"/>
              </a:ext>
            </a:extLst>
          </p:cNvPr>
          <p:cNvSpPr txBox="1"/>
          <p:nvPr/>
        </p:nvSpPr>
        <p:spPr>
          <a:xfrm>
            <a:off x="4863354" y="354912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188365" y="398850"/>
            <a:ext cx="61150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The </a:t>
            </a:r>
            <a:r>
              <a:rPr lang="en-U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bag3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ardiomyopathy model exhibited accelerated cardiac aging phenotypes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E876B8EC-2681-CC88-80FF-6B62D9E210EA}"/>
              </a:ext>
            </a:extLst>
          </p:cNvPr>
          <p:cNvSpPr txBox="1"/>
          <p:nvPr/>
        </p:nvSpPr>
        <p:spPr>
          <a:xfrm rot="16200000">
            <a:off x="45759" y="4419543"/>
            <a:ext cx="156855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lative RNA levels</a:t>
            </a:r>
          </a:p>
        </p:txBody>
      </p:sp>
      <p:sp>
        <p:nvSpPr>
          <p:cNvPr id="2" name="Rectangle 1"/>
          <p:cNvSpPr/>
          <p:nvPr/>
        </p:nvSpPr>
        <p:spPr>
          <a:xfrm>
            <a:off x="355547" y="5593968"/>
            <a:ext cx="6199631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-B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Representative 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ages of senescence-associated β-galactosidase activity (SA-β-gal) staining in the whole fish body (A) and heart chamber (B) at 6 months of age. Arrows indicate positive SA-β-gal staining signals.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-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uantitative RT-PCR analysis of the senescence marker p21 and SASPs. n=3 biological replicates, one-way ANOVA. Scale bars in A, 1 cm; B, 100 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68995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Z:\SHARED\Ding Yonghe\RNAseq-Yuji\TFEB volcano_plot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2324" y="1539691"/>
            <a:ext cx="2656411" cy="19923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0F7BD473-FA16-46E8-7664-4025835AC664}"/>
              </a:ext>
            </a:extLst>
          </p:cNvPr>
          <p:cNvSpPr txBox="1"/>
          <p:nvPr/>
        </p:nvSpPr>
        <p:spPr>
          <a:xfrm>
            <a:off x="3068200" y="132239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530984"/>
              </p:ext>
            </p:extLst>
          </p:nvPr>
        </p:nvGraphicFramePr>
        <p:xfrm>
          <a:off x="3253302" y="1641010"/>
          <a:ext cx="3228521" cy="178117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848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436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Ingenuity Canonical Pathways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 -log(p-value)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ell Cycle Checkpoints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5.9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Mitotic Prometaphase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0.3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Activation of the pre-replicative complex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7.8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Kinetochore Metaphase Signaling Pathway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.4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Synthesis of DNA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6.3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Cell Cycle Control of Chromosomal Replication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3.6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RHO GTPases Activate Formins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3.4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itotic Metaphase and Anaphase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2.5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Mitotic G1 phase and G1/S transition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1.6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Hereditary Breast Cancer Signaling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9.53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95477" y="488578"/>
            <a:ext cx="63907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Volcano plot representation of differentially expressed genes and IPA pathway analysis</a:t>
            </a:r>
            <a:endParaRPr lang="en-US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F7BD473-FA16-46E8-7664-4025835AC664}"/>
              </a:ext>
            </a:extLst>
          </p:cNvPr>
          <p:cNvSpPr txBox="1"/>
          <p:nvPr/>
        </p:nvSpPr>
        <p:spPr>
          <a:xfrm>
            <a:off x="187160" y="135003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F7BD473-FA16-46E8-7664-4025835AC664}"/>
              </a:ext>
            </a:extLst>
          </p:cNvPr>
          <p:cNvSpPr txBox="1"/>
          <p:nvPr/>
        </p:nvSpPr>
        <p:spPr>
          <a:xfrm>
            <a:off x="230717" y="3650198"/>
            <a:ext cx="27568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6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F7BD473-FA16-46E8-7664-4025835AC664}"/>
              </a:ext>
            </a:extLst>
          </p:cNvPr>
          <p:cNvSpPr txBox="1"/>
          <p:nvPr/>
        </p:nvSpPr>
        <p:spPr>
          <a:xfrm>
            <a:off x="3087231" y="359804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6" name="Picture 2" descr="Z:\SHARED\Ding Yonghe\RNAseq-Yuji\mTOR_volcano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058" y="3936599"/>
            <a:ext cx="2628608" cy="18937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26054408"/>
              </p:ext>
            </p:extLst>
          </p:nvPr>
        </p:nvGraphicFramePr>
        <p:xfrm>
          <a:off x="3284766" y="3983057"/>
          <a:ext cx="3185482" cy="19523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49329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9218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7579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</a:rPr>
                        <a:t>Ingenuity Canonical Pathways</a:t>
                      </a:r>
                      <a:endParaRPr lang="en-US" sz="8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</a:rPr>
                        <a:t> -log(p-value)</a:t>
                      </a:r>
                      <a:endParaRPr lang="en-US" sz="800" b="0" i="0" u="none" strike="noStrike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52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Circadian Clock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3.61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2893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Protein folding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96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219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Macrophage Alternative Activation Signaling Pathway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2.15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69466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NR1D1 (REV-ERBA) represses gene expression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09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5354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NGF processing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09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702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PRPP Biosynthesis I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09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Oxidized GTP and </a:t>
                      </a:r>
                      <a:r>
                        <a:rPr lang="en-US" sz="1000" u="none" strike="noStrike" dirty="0" err="1">
                          <a:effectLst/>
                        </a:rPr>
                        <a:t>dGTP</a:t>
                      </a:r>
                      <a:r>
                        <a:rPr lang="en-US" sz="1000" u="none" strike="noStrike" dirty="0">
                          <a:effectLst/>
                        </a:rPr>
                        <a:t> Detoxification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09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2602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Transmission across Electrical Synapses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99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84437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Glycogen Biosynthesis II (from UDP-D-Glucose)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.84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25980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Unfolded protein response</a:t>
                      </a:r>
                      <a:endParaRPr lang="en-US" sz="1000" b="0" i="0" u="none" strike="noStrike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.83</a:t>
                      </a:r>
                      <a:endParaRPr lang="en-US" sz="1000" b="0" i="0" u="none" strike="noStrike" dirty="0">
                        <a:effectLst/>
                        <a:latin typeface="Arial"/>
                      </a:endParaRPr>
                    </a:p>
                  </a:txBody>
                  <a:tcPr marL="7937" marR="7937" marT="7937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69907" y="6281832"/>
            <a:ext cx="639076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-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Volcano plot representation of differentially expressed genes in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xu015/+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tant (A) 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(cmlc2:tfe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genic hearts (B)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-D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p 10 pathways enriched in differentially expressed genes as identified by IPA pathway analysis in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xu015/+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utant (C) 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(cmlc2:tfe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genic hearts (D). 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67767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" name="Picture 25" descr="A graph of a number of objects&#10;&#10;AI-generated content may be incorrect.">
            <a:extLst>
              <a:ext uri="{FF2B5EF4-FFF2-40B4-BE49-F238E27FC236}">
                <a16:creationId xmlns:a16="http://schemas.microsoft.com/office/drawing/2014/main" id="{00CE86D4-4C6B-AECE-9164-9BFDB73D10C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35" t="12447" r="6744" b="31443"/>
          <a:stretch>
            <a:fillRect/>
          </a:stretch>
        </p:blipFill>
        <p:spPr>
          <a:xfrm>
            <a:off x="2611289" y="1135938"/>
            <a:ext cx="1675315" cy="1460720"/>
          </a:xfrm>
          <a:prstGeom prst="rect">
            <a:avLst/>
          </a:prstGeom>
        </p:spPr>
      </p:pic>
      <p:pic>
        <p:nvPicPr>
          <p:cNvPr id="28" name="Picture 27" descr="A graph of a number of objects&#10;&#10;AI-generated content may be incorrect.">
            <a:extLst>
              <a:ext uri="{FF2B5EF4-FFF2-40B4-BE49-F238E27FC236}">
                <a16:creationId xmlns:a16="http://schemas.microsoft.com/office/drawing/2014/main" id="{008AF359-F039-E2A1-A98B-92D56634E68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69" t="10419" r="7887" b="31182"/>
          <a:stretch>
            <a:fillRect/>
          </a:stretch>
        </p:blipFill>
        <p:spPr>
          <a:xfrm>
            <a:off x="4707665" y="1031189"/>
            <a:ext cx="1728416" cy="1574451"/>
          </a:xfrm>
          <a:prstGeom prst="rect">
            <a:avLst/>
          </a:prstGeom>
        </p:spPr>
      </p:pic>
      <p:pic>
        <p:nvPicPr>
          <p:cNvPr id="30" name="Picture 29" descr="A graph of a number of cells&#10;&#10;AI-generated content may be incorrect.">
            <a:extLst>
              <a:ext uri="{FF2B5EF4-FFF2-40B4-BE49-F238E27FC236}">
                <a16:creationId xmlns:a16="http://schemas.microsoft.com/office/drawing/2014/main" id="{45BC7F04-6DB2-C79D-8D83-10C0C36C18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423" t="12493" r="21014" b="30974"/>
          <a:stretch>
            <a:fillRect/>
          </a:stretch>
        </p:blipFill>
        <p:spPr>
          <a:xfrm>
            <a:off x="3996600" y="3563500"/>
            <a:ext cx="1634072" cy="150603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030E9F8-757B-0696-62B5-E63EC8081608}"/>
              </a:ext>
            </a:extLst>
          </p:cNvPr>
          <p:cNvSpPr txBox="1"/>
          <p:nvPr/>
        </p:nvSpPr>
        <p:spPr>
          <a:xfrm>
            <a:off x="64667" y="181101"/>
            <a:ext cx="6728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</a:t>
            </a:r>
            <a:r>
              <a:rPr lang="en-US" sz="1200" b="1" i="1" dirty="0">
                <a:latin typeface="Arial" panose="020B0604020202020204" pitchFamily="34" charset="0"/>
                <a:ea typeface="SimSun" panose="02010600030101010101" pitchFamily="2" charset="-122"/>
              </a:rPr>
              <a:t>fabp7a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</a:rPr>
              <a:t> inhibition partially restores impaired protein homeostasis in the </a:t>
            </a:r>
            <a:r>
              <a:rPr lang="en-US" sz="1200" b="1" i="1" dirty="0">
                <a:latin typeface="Arial" panose="020B0604020202020204" pitchFamily="34" charset="0"/>
                <a:ea typeface="SimSun" panose="02010600030101010101" pitchFamily="2" charset="-122"/>
              </a:rPr>
              <a:t>bag3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</a:rPr>
              <a:t> cardiomyopathy model</a:t>
            </a:r>
            <a:endParaRPr lang="en-US" sz="12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4BD8F98-B8C1-B987-045F-85BA15AD3279}"/>
              </a:ext>
            </a:extLst>
          </p:cNvPr>
          <p:cNvSpPr txBox="1"/>
          <p:nvPr/>
        </p:nvSpPr>
        <p:spPr>
          <a:xfrm rot="16200000">
            <a:off x="2887695" y="4067991"/>
            <a:ext cx="195266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lative insoluble ubiquitinated protein level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2EE742F5-9A83-A01B-D8DE-F7E419218033}"/>
              </a:ext>
            </a:extLst>
          </p:cNvPr>
          <p:cNvSpPr txBox="1"/>
          <p:nvPr/>
        </p:nvSpPr>
        <p:spPr>
          <a:xfrm rot="16200000">
            <a:off x="1494291" y="1591292"/>
            <a:ext cx="182067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lative Hsp70 protein level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47E1D79-9D1C-AF96-36E4-D11759EE0D9F}"/>
              </a:ext>
            </a:extLst>
          </p:cNvPr>
          <p:cNvSpPr txBox="1"/>
          <p:nvPr/>
        </p:nvSpPr>
        <p:spPr>
          <a:xfrm rot="16200000">
            <a:off x="3689466" y="1601582"/>
            <a:ext cx="174168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elative Hsc70 protein level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B4CB2F8-D248-9AB4-2BD0-529DB6C0F0E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0"/>
                    </a14:imgEffect>
                    <a14:imgEffect>
                      <a14:brightnessContrast bright="25000" contrast="29000"/>
                    </a14:imgEffect>
                  </a14:imgLayer>
                </a14:imgProps>
              </a:ext>
            </a:extLst>
          </a:blip>
          <a:srcRect t="4137"/>
          <a:stretch>
            <a:fillRect/>
          </a:stretch>
        </p:blipFill>
        <p:spPr>
          <a:xfrm>
            <a:off x="2087264" y="3388483"/>
            <a:ext cx="1409401" cy="215348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AF0D021B-CD35-1AFF-BF54-B52AC6870E8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7000" contrast="43000"/>
                    </a14:imgEffect>
                  </a14:imgLayer>
                </a14:imgProps>
              </a:ext>
            </a:extLst>
          </a:blip>
          <a:srcRect/>
          <a:stretch>
            <a:fillRect/>
          </a:stretch>
        </p:blipFill>
        <p:spPr>
          <a:xfrm>
            <a:off x="498503" y="3388483"/>
            <a:ext cx="1553423" cy="2153480"/>
          </a:xfrm>
          <a:prstGeom prst="rect">
            <a:avLst/>
          </a:prstGeom>
        </p:spPr>
      </p:pic>
      <p:grpSp>
        <p:nvGrpSpPr>
          <p:cNvPr id="59" name="Group 58">
            <a:extLst>
              <a:ext uri="{FF2B5EF4-FFF2-40B4-BE49-F238E27FC236}">
                <a16:creationId xmlns:a16="http://schemas.microsoft.com/office/drawing/2014/main" id="{071D0DEA-476A-72A3-A383-EFC2528B7E2D}"/>
              </a:ext>
            </a:extLst>
          </p:cNvPr>
          <p:cNvGrpSpPr/>
          <p:nvPr/>
        </p:nvGrpSpPr>
        <p:grpSpPr>
          <a:xfrm>
            <a:off x="781040" y="1185497"/>
            <a:ext cx="1282919" cy="829998"/>
            <a:chOff x="423756" y="1989006"/>
            <a:chExt cx="1409403" cy="99654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CCABFE9-A161-025A-7F22-F9EBBD6A5C2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saturation sat="0"/>
                      </a14:imgEffect>
                      <a14:imgEffect>
                        <a14:brightnessContrast bright="42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3758" y="2320702"/>
              <a:ext cx="1409401" cy="289057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8A731817-A97F-2DF7-4C9A-5447CBD5B07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saturation sat="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 flipH="1">
              <a:off x="423756" y="2641075"/>
              <a:ext cx="1409401" cy="344478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F837AA6-36E6-3F77-0893-3B4D4AE4D839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saturation sat="0"/>
                      </a14:imgEffect>
                      <a14:imgEffect>
                        <a14:brightnessContrast bright="39000" contrast="9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423758" y="1989006"/>
              <a:ext cx="1409401" cy="289057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73DCC56-513C-41D8-ED11-F50E319DFA3B}"/>
              </a:ext>
            </a:extLst>
          </p:cNvPr>
          <p:cNvSpPr txBox="1"/>
          <p:nvPr/>
        </p:nvSpPr>
        <p:spPr>
          <a:xfrm>
            <a:off x="234553" y="1722007"/>
            <a:ext cx="8421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D162130-7E63-A3A9-1E64-9F8E62BA3F57}"/>
              </a:ext>
            </a:extLst>
          </p:cNvPr>
          <p:cNvSpPr txBox="1"/>
          <p:nvPr/>
        </p:nvSpPr>
        <p:spPr>
          <a:xfrm>
            <a:off x="237633" y="1177837"/>
            <a:ext cx="8421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sp7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4F624C6-0C29-616A-6986-C671B12DBF43}"/>
              </a:ext>
            </a:extLst>
          </p:cNvPr>
          <p:cNvSpPr txBox="1"/>
          <p:nvPr/>
        </p:nvSpPr>
        <p:spPr>
          <a:xfrm>
            <a:off x="262772" y="1456239"/>
            <a:ext cx="84210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sc70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09A5EFF-31DF-12C8-0359-B6E267798554}"/>
              </a:ext>
            </a:extLst>
          </p:cNvPr>
          <p:cNvSpPr txBox="1"/>
          <p:nvPr/>
        </p:nvSpPr>
        <p:spPr>
          <a:xfrm>
            <a:off x="2409625" y="3167732"/>
            <a:ext cx="84464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biquit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59D83150-F4DB-5A79-AF67-BAF54B248D37}"/>
              </a:ext>
            </a:extLst>
          </p:cNvPr>
          <p:cNvSpPr txBox="1"/>
          <p:nvPr/>
        </p:nvSpPr>
        <p:spPr>
          <a:xfrm>
            <a:off x="910964" y="3164497"/>
            <a:ext cx="94865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omassie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6118CE1E-EA08-CB45-6676-6E53A336DC86}"/>
              </a:ext>
            </a:extLst>
          </p:cNvPr>
          <p:cNvSpPr txBox="1"/>
          <p:nvPr/>
        </p:nvSpPr>
        <p:spPr>
          <a:xfrm rot="18932373">
            <a:off x="1355784" y="5599352"/>
            <a:ext cx="894479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C61F50DA-D30A-9528-F045-418CAE66587A}"/>
              </a:ext>
            </a:extLst>
          </p:cNvPr>
          <p:cNvSpPr txBox="1"/>
          <p:nvPr/>
        </p:nvSpPr>
        <p:spPr>
          <a:xfrm rot="18932373">
            <a:off x="961334" y="5718736"/>
            <a:ext cx="8509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A2AB6EF-E4D3-ACF0-5375-4506C93C49D4}"/>
              </a:ext>
            </a:extLst>
          </p:cNvPr>
          <p:cNvSpPr txBox="1"/>
          <p:nvPr/>
        </p:nvSpPr>
        <p:spPr>
          <a:xfrm rot="18932373">
            <a:off x="690546" y="5685507"/>
            <a:ext cx="792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F63EE25-F47A-42AC-8717-E08FD12FEA0B}"/>
              </a:ext>
            </a:extLst>
          </p:cNvPr>
          <p:cNvSpPr txBox="1"/>
          <p:nvPr/>
        </p:nvSpPr>
        <p:spPr>
          <a:xfrm rot="18932373">
            <a:off x="672993" y="5573858"/>
            <a:ext cx="427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4923B96-D4F9-ABE6-DFEF-D1EC10419E8D}"/>
              </a:ext>
            </a:extLst>
          </p:cNvPr>
          <p:cNvSpPr txBox="1"/>
          <p:nvPr/>
        </p:nvSpPr>
        <p:spPr>
          <a:xfrm rot="18932373">
            <a:off x="175546" y="5615385"/>
            <a:ext cx="64060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adder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587B5A8-051E-D0FC-81A1-E63AFA4EF07C}"/>
              </a:ext>
            </a:extLst>
          </p:cNvPr>
          <p:cNvSpPr txBox="1"/>
          <p:nvPr/>
        </p:nvSpPr>
        <p:spPr>
          <a:xfrm rot="18932373">
            <a:off x="1383141" y="2108839"/>
            <a:ext cx="88312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BDE4E49-90A0-9A03-8F32-BD3C678E6C6A}"/>
              </a:ext>
            </a:extLst>
          </p:cNvPr>
          <p:cNvSpPr txBox="1"/>
          <p:nvPr/>
        </p:nvSpPr>
        <p:spPr>
          <a:xfrm rot="18932373">
            <a:off x="882401" y="2188719"/>
            <a:ext cx="94576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27E1C4E-BFAB-46FF-BC24-6A57DF71994D}"/>
              </a:ext>
            </a:extLst>
          </p:cNvPr>
          <p:cNvSpPr txBox="1"/>
          <p:nvPr/>
        </p:nvSpPr>
        <p:spPr>
          <a:xfrm rot="18932373">
            <a:off x="693240" y="2166665"/>
            <a:ext cx="792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97B768FA-589B-28C6-B4B2-9CE45575226E}"/>
              </a:ext>
            </a:extLst>
          </p:cNvPr>
          <p:cNvSpPr txBox="1"/>
          <p:nvPr/>
        </p:nvSpPr>
        <p:spPr>
          <a:xfrm rot="18932373">
            <a:off x="675687" y="2035966"/>
            <a:ext cx="427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7C20E36E-D483-11CB-AE8B-DCFF29D4F102}"/>
              </a:ext>
            </a:extLst>
          </p:cNvPr>
          <p:cNvSpPr txBox="1"/>
          <p:nvPr/>
        </p:nvSpPr>
        <p:spPr>
          <a:xfrm rot="18932373">
            <a:off x="2759293" y="5657201"/>
            <a:ext cx="8273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73AF8C2C-6165-860C-A01B-B91D9DFACCE4}"/>
              </a:ext>
            </a:extLst>
          </p:cNvPr>
          <p:cNvSpPr txBox="1"/>
          <p:nvPr/>
        </p:nvSpPr>
        <p:spPr>
          <a:xfrm rot="18932373">
            <a:off x="2309026" y="5709530"/>
            <a:ext cx="8509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62E2E32-6B66-4070-E239-CFBB075D41E5}"/>
              </a:ext>
            </a:extLst>
          </p:cNvPr>
          <p:cNvSpPr txBox="1"/>
          <p:nvPr/>
        </p:nvSpPr>
        <p:spPr>
          <a:xfrm rot="18932373">
            <a:off x="2051863" y="5672201"/>
            <a:ext cx="792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47FB770-6E4D-81FB-5AC5-A9F7D3F5A60F}"/>
              </a:ext>
            </a:extLst>
          </p:cNvPr>
          <p:cNvSpPr txBox="1"/>
          <p:nvPr/>
        </p:nvSpPr>
        <p:spPr>
          <a:xfrm rot="18932373">
            <a:off x="2011160" y="5564652"/>
            <a:ext cx="427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1F5E4856-6A49-E19A-9740-673752FF2BB9}"/>
              </a:ext>
            </a:extLst>
          </p:cNvPr>
          <p:cNvSpPr txBox="1"/>
          <p:nvPr/>
        </p:nvSpPr>
        <p:spPr>
          <a:xfrm>
            <a:off x="175619" y="81239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99538168-A310-8A51-E07A-14FABC2AC00E}"/>
              </a:ext>
            </a:extLst>
          </p:cNvPr>
          <p:cNvSpPr txBox="1"/>
          <p:nvPr/>
        </p:nvSpPr>
        <p:spPr>
          <a:xfrm>
            <a:off x="158243" y="308457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E9BB8EBB-844B-191D-BAF3-BC15054DFA3A}"/>
              </a:ext>
            </a:extLst>
          </p:cNvPr>
          <p:cNvSpPr txBox="1"/>
          <p:nvPr/>
        </p:nvSpPr>
        <p:spPr>
          <a:xfrm>
            <a:off x="4126070" y="81239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9D9B5F5F-6054-D715-453D-40CD30EBEB43}"/>
              </a:ext>
            </a:extLst>
          </p:cNvPr>
          <p:cNvCxnSpPr>
            <a:cxnSpLocks/>
          </p:cNvCxnSpPr>
          <p:nvPr/>
        </p:nvCxnSpPr>
        <p:spPr>
          <a:xfrm>
            <a:off x="3387791" y="1469553"/>
            <a:ext cx="6305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7AC3F750-0B71-4EDE-894F-17B68384B833}"/>
              </a:ext>
            </a:extLst>
          </p:cNvPr>
          <p:cNvSpPr txBox="1"/>
          <p:nvPr/>
        </p:nvSpPr>
        <p:spPr>
          <a:xfrm>
            <a:off x="2832380" y="1093066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02</a:t>
            </a:r>
          </a:p>
        </p:txBody>
      </p: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C477CC01-D8E4-E5D7-71E0-A61AB66F3967}"/>
              </a:ext>
            </a:extLst>
          </p:cNvPr>
          <p:cNvCxnSpPr>
            <a:cxnSpLocks/>
          </p:cNvCxnSpPr>
          <p:nvPr/>
        </p:nvCxnSpPr>
        <p:spPr>
          <a:xfrm>
            <a:off x="3015423" y="1318200"/>
            <a:ext cx="315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F45B2C2B-02FC-3349-37DF-D4BA549FC7D9}"/>
              </a:ext>
            </a:extLst>
          </p:cNvPr>
          <p:cNvSpPr txBox="1"/>
          <p:nvPr/>
        </p:nvSpPr>
        <p:spPr>
          <a:xfrm>
            <a:off x="3333212" y="1248466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08</a:t>
            </a:r>
          </a:p>
        </p:txBody>
      </p: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B313E106-3182-1C8A-6855-3381E8777F6B}"/>
              </a:ext>
            </a:extLst>
          </p:cNvPr>
          <p:cNvCxnSpPr>
            <a:cxnSpLocks/>
          </p:cNvCxnSpPr>
          <p:nvPr/>
        </p:nvCxnSpPr>
        <p:spPr>
          <a:xfrm>
            <a:off x="5567526" y="1376707"/>
            <a:ext cx="6305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id="{AD045588-AFBB-E706-F464-D7FB588FF044}"/>
              </a:ext>
            </a:extLst>
          </p:cNvPr>
          <p:cNvSpPr txBox="1"/>
          <p:nvPr/>
        </p:nvSpPr>
        <p:spPr>
          <a:xfrm>
            <a:off x="5012115" y="1000220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55</a:t>
            </a:r>
          </a:p>
        </p:txBody>
      </p: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9B140162-5F50-57C5-DCAC-F2600638D1D4}"/>
              </a:ext>
            </a:extLst>
          </p:cNvPr>
          <p:cNvCxnSpPr>
            <a:cxnSpLocks/>
          </p:cNvCxnSpPr>
          <p:nvPr/>
        </p:nvCxnSpPr>
        <p:spPr>
          <a:xfrm>
            <a:off x="5195158" y="1225354"/>
            <a:ext cx="315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FCD59D1A-075B-97DC-39D9-C06FC7A29D00}"/>
              </a:ext>
            </a:extLst>
          </p:cNvPr>
          <p:cNvSpPr txBox="1"/>
          <p:nvPr/>
        </p:nvSpPr>
        <p:spPr>
          <a:xfrm>
            <a:off x="5512947" y="1155620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131</a:t>
            </a:r>
          </a:p>
        </p:txBody>
      </p: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1129C288-5ED4-ADA0-5A33-497AB183A6BB}"/>
              </a:ext>
            </a:extLst>
          </p:cNvPr>
          <p:cNvCxnSpPr>
            <a:cxnSpLocks/>
          </p:cNvCxnSpPr>
          <p:nvPr/>
        </p:nvCxnSpPr>
        <p:spPr>
          <a:xfrm>
            <a:off x="4828788" y="3800486"/>
            <a:ext cx="6305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8CE99158-B82A-9C4E-DD44-4947A68B7A8D}"/>
              </a:ext>
            </a:extLst>
          </p:cNvPr>
          <p:cNvSpPr txBox="1"/>
          <p:nvPr/>
        </p:nvSpPr>
        <p:spPr>
          <a:xfrm>
            <a:off x="4275757" y="3448008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18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6BE8C225-0BA0-E2EF-D46D-27373679D984}"/>
              </a:ext>
            </a:extLst>
          </p:cNvPr>
          <p:cNvCxnSpPr>
            <a:cxnSpLocks/>
          </p:cNvCxnSpPr>
          <p:nvPr/>
        </p:nvCxnSpPr>
        <p:spPr>
          <a:xfrm>
            <a:off x="4447618" y="3673728"/>
            <a:ext cx="315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0CEF4A3B-AAFA-01C8-DB9C-F8233D3B47A2}"/>
              </a:ext>
            </a:extLst>
          </p:cNvPr>
          <p:cNvSpPr txBox="1"/>
          <p:nvPr/>
        </p:nvSpPr>
        <p:spPr>
          <a:xfrm>
            <a:off x="4774209" y="3579399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30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1FC2156-CB4A-963C-40D3-FB7BED87F2EB}"/>
              </a:ext>
            </a:extLst>
          </p:cNvPr>
          <p:cNvSpPr txBox="1"/>
          <p:nvPr/>
        </p:nvSpPr>
        <p:spPr>
          <a:xfrm rot="18932373">
            <a:off x="3506420" y="2601069"/>
            <a:ext cx="87918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9FA0C1-F076-8BDC-1B77-522978903D02}"/>
              </a:ext>
            </a:extLst>
          </p:cNvPr>
          <p:cNvSpPr txBox="1"/>
          <p:nvPr/>
        </p:nvSpPr>
        <p:spPr>
          <a:xfrm rot="18932373">
            <a:off x="3038440" y="2638945"/>
            <a:ext cx="936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C41A1B5-C995-6F80-1B4C-EB7E71679D2F}"/>
              </a:ext>
            </a:extLst>
          </p:cNvPr>
          <p:cNvSpPr txBox="1"/>
          <p:nvPr/>
        </p:nvSpPr>
        <p:spPr>
          <a:xfrm rot="18932373">
            <a:off x="2780741" y="2635660"/>
            <a:ext cx="792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DAE3A01-5891-CF42-0973-F84119D57985}"/>
              </a:ext>
            </a:extLst>
          </p:cNvPr>
          <p:cNvSpPr txBox="1"/>
          <p:nvPr/>
        </p:nvSpPr>
        <p:spPr>
          <a:xfrm rot="18932373">
            <a:off x="2729172" y="2527153"/>
            <a:ext cx="427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299E0DE-9309-87E7-D327-2C9AB8C2818D}"/>
              </a:ext>
            </a:extLst>
          </p:cNvPr>
          <p:cNvSpPr txBox="1"/>
          <p:nvPr/>
        </p:nvSpPr>
        <p:spPr>
          <a:xfrm rot="18932373">
            <a:off x="5693997" y="2611284"/>
            <a:ext cx="86331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D096BB7-1878-E5A3-10D9-B0BCAA4FBA0E}"/>
              </a:ext>
            </a:extLst>
          </p:cNvPr>
          <p:cNvSpPr txBox="1"/>
          <p:nvPr/>
        </p:nvSpPr>
        <p:spPr>
          <a:xfrm rot="18932373">
            <a:off x="5245131" y="2644194"/>
            <a:ext cx="936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48E1F7C-43A1-AAB6-35EE-F1DDD89CF47F}"/>
              </a:ext>
            </a:extLst>
          </p:cNvPr>
          <p:cNvSpPr txBox="1"/>
          <p:nvPr/>
        </p:nvSpPr>
        <p:spPr>
          <a:xfrm rot="18932373">
            <a:off x="4987432" y="2640909"/>
            <a:ext cx="792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CB1C4CE-8DA2-908E-47BE-775C15ED7599}"/>
              </a:ext>
            </a:extLst>
          </p:cNvPr>
          <p:cNvSpPr txBox="1"/>
          <p:nvPr/>
        </p:nvSpPr>
        <p:spPr>
          <a:xfrm rot="18932373">
            <a:off x="4935863" y="2532402"/>
            <a:ext cx="427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F0207EC-A540-FD7D-6F1B-78A40972B9CD}"/>
              </a:ext>
            </a:extLst>
          </p:cNvPr>
          <p:cNvSpPr txBox="1"/>
          <p:nvPr/>
        </p:nvSpPr>
        <p:spPr>
          <a:xfrm rot="18932373">
            <a:off x="4948839" y="5048688"/>
            <a:ext cx="89722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E09FC9E-4A05-2660-E6E7-8C717C2D89DC}"/>
              </a:ext>
            </a:extLst>
          </p:cNvPr>
          <p:cNvSpPr txBox="1"/>
          <p:nvPr/>
        </p:nvSpPr>
        <p:spPr>
          <a:xfrm rot="18932373">
            <a:off x="4489320" y="5105207"/>
            <a:ext cx="936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A562551-F724-DDE2-F762-4836F68ACE50}"/>
              </a:ext>
            </a:extLst>
          </p:cNvPr>
          <p:cNvSpPr txBox="1"/>
          <p:nvPr/>
        </p:nvSpPr>
        <p:spPr>
          <a:xfrm rot="18932373">
            <a:off x="4250671" y="5101922"/>
            <a:ext cx="792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57D313B-A6B3-588D-4DE5-62BAD762F574}"/>
              </a:ext>
            </a:extLst>
          </p:cNvPr>
          <p:cNvSpPr txBox="1"/>
          <p:nvPr/>
        </p:nvSpPr>
        <p:spPr>
          <a:xfrm rot="18932373">
            <a:off x="4218152" y="4993415"/>
            <a:ext cx="427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7CC4687-1FBF-47EB-3878-5BE982C08AFB}"/>
              </a:ext>
            </a:extLst>
          </p:cNvPr>
          <p:cNvSpPr txBox="1"/>
          <p:nvPr/>
        </p:nvSpPr>
        <p:spPr>
          <a:xfrm>
            <a:off x="21416" y="6247824"/>
            <a:ext cx="68550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-E,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estern blot (A and D) and quantification of Hsp70 (B), Hsc70 (C) and insoluble ubiquitinated protein (E) levels in heart lysate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;fabp7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uble mutants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ingle mutants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, fabp7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ngle mutants, and WT control fish at 6 months of age. n=3, one-way ANOVA.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1611199-27F0-70CA-5A5F-BDAD59DEE7DA}"/>
              </a:ext>
            </a:extLst>
          </p:cNvPr>
          <p:cNvSpPr txBox="1"/>
          <p:nvPr/>
        </p:nvSpPr>
        <p:spPr>
          <a:xfrm>
            <a:off x="3576635" y="3137825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829F17E-F9B7-A97A-BA3C-F6C57832B2B6}"/>
              </a:ext>
            </a:extLst>
          </p:cNvPr>
          <p:cNvSpPr txBox="1"/>
          <p:nvPr/>
        </p:nvSpPr>
        <p:spPr>
          <a:xfrm>
            <a:off x="1981356" y="81239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838888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" name="Picture 27" descr="Z:\IMAGING\Zeiss-Axio\Yonghe\3-17-15(bag3-TUNEL)\bag3-CM-(new)\MD-Experiment-0007\MD-Experiment-0007_(c1+c3).JPG">
            <a:extLst>
              <a:ext uri="{FF2B5EF4-FFF2-40B4-BE49-F238E27FC236}">
                <a16:creationId xmlns:a16="http://schemas.microsoft.com/office/drawing/2014/main" id="{D2F4CDE8-02DF-F1AF-B8FC-2104D3C12F0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55000" contrast="3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773" t="18617" r="21007" b="50958"/>
          <a:stretch>
            <a:fillRect/>
          </a:stretch>
        </p:blipFill>
        <p:spPr bwMode="auto">
          <a:xfrm>
            <a:off x="4546733" y="2270674"/>
            <a:ext cx="1201679" cy="1086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Picture 28" descr="Z:\IMAGING\Zeiss-Axio\Yonghe\3-17-15(bag3-TUNEL)\bag3-CM-(new)\MD-Experiment-0007\MD-Experiment-0007_c1.JPG">
            <a:extLst>
              <a:ext uri="{FF2B5EF4-FFF2-40B4-BE49-F238E27FC236}">
                <a16:creationId xmlns:a16="http://schemas.microsoft.com/office/drawing/2014/main" id="{646D1A0A-3A33-8A75-A33F-E0883549437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64000" contras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773" t="18617" r="21007" b="50958"/>
          <a:stretch>
            <a:fillRect/>
          </a:stretch>
        </p:blipFill>
        <p:spPr bwMode="auto">
          <a:xfrm>
            <a:off x="4546733" y="1159196"/>
            <a:ext cx="1201679" cy="1086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" name="Picture 29" descr="A blue and green glowing cloud&#10;&#10;AI-generated content may be incorrect.">
            <a:extLst>
              <a:ext uri="{FF2B5EF4-FFF2-40B4-BE49-F238E27FC236}">
                <a16:creationId xmlns:a16="http://schemas.microsoft.com/office/drawing/2014/main" id="{8E85782C-2671-B3E5-A38D-8C31778201C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5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123" t="25736" r="48251" b="43839"/>
          <a:stretch>
            <a:fillRect/>
          </a:stretch>
        </p:blipFill>
        <p:spPr>
          <a:xfrm>
            <a:off x="3313545" y="2270673"/>
            <a:ext cx="1211510" cy="1086933"/>
          </a:xfrm>
          <a:prstGeom prst="rect">
            <a:avLst/>
          </a:prstGeom>
        </p:spPr>
      </p:pic>
      <p:pic>
        <p:nvPicPr>
          <p:cNvPr id="31" name="Picture 30" descr="A green light in the dark&#10;&#10;AI-generated content may be incorrect.">
            <a:extLst>
              <a:ext uri="{FF2B5EF4-FFF2-40B4-BE49-F238E27FC236}">
                <a16:creationId xmlns:a16="http://schemas.microsoft.com/office/drawing/2014/main" id="{22DCBA12-6A3E-E999-4EF5-41D75C4F81D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997" t="25736" r="48376" b="43839"/>
          <a:stretch>
            <a:fillRect/>
          </a:stretch>
        </p:blipFill>
        <p:spPr>
          <a:xfrm>
            <a:off x="3313544" y="1160415"/>
            <a:ext cx="1211510" cy="1086932"/>
          </a:xfrm>
          <a:prstGeom prst="rect">
            <a:avLst/>
          </a:prstGeom>
        </p:spPr>
      </p:pic>
      <p:pic>
        <p:nvPicPr>
          <p:cNvPr id="32" name="Picture 2" descr="Z:\IMAGING\Zeiss-Axio\Yonghe\3-17-15(bag3-TUNEL)\Normal control\MD-Experiment-0002\MD-Experiment-0002_c1.JPG">
            <a:extLst>
              <a:ext uri="{FF2B5EF4-FFF2-40B4-BE49-F238E27FC236}">
                <a16:creationId xmlns:a16="http://schemas.microsoft.com/office/drawing/2014/main" id="{973A8CEE-8EF0-6A0E-A4AE-3A901983863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52000" contras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061" t="39873" r="16197" b="29702"/>
          <a:stretch>
            <a:fillRect/>
          </a:stretch>
        </p:blipFill>
        <p:spPr bwMode="auto">
          <a:xfrm>
            <a:off x="766602" y="1160415"/>
            <a:ext cx="1254238" cy="1086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3" name="Picture 4" descr="Z:\IMAGING\Zeiss-Axio\Yonghe\3-17-15(bag3-TUNEL)\Normal control\MD-Experiment-0002\MD-Experiment-0002_(c1+c3).JPG">
            <a:extLst>
              <a:ext uri="{FF2B5EF4-FFF2-40B4-BE49-F238E27FC236}">
                <a16:creationId xmlns:a16="http://schemas.microsoft.com/office/drawing/2014/main" id="{A7ED00B8-AC1C-686F-4BD2-DD9D84EC27D8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65000" contras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130" t="39873" r="16158" b="29702"/>
          <a:stretch>
            <a:fillRect/>
          </a:stretch>
        </p:blipFill>
        <p:spPr bwMode="auto">
          <a:xfrm>
            <a:off x="766602" y="2270673"/>
            <a:ext cx="1252447" cy="10869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4" name="Picture 11" descr="Z:\IMAGING\Zeiss-Axio\Yonghe\3-17-15(bag3-TUNEL)\bag3-homo-1\MD-Experiment-0003\MD-Experiment-0003_c1.JPG">
            <a:extLst>
              <a:ext uri="{FF2B5EF4-FFF2-40B4-BE49-F238E27FC236}">
                <a16:creationId xmlns:a16="http://schemas.microsoft.com/office/drawing/2014/main" id="{81ED2A0F-D17F-D9C8-5429-66EE5AEC80B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55000" contras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555" t="27926" r="36731" b="41627"/>
          <a:stretch>
            <a:fillRect/>
          </a:stretch>
        </p:blipFill>
        <p:spPr bwMode="auto">
          <a:xfrm rot="10800000">
            <a:off x="2040727" y="1160415"/>
            <a:ext cx="1253145" cy="10877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5" name="Picture 13" descr="Z:\IMAGING\Zeiss-Axio\Yonghe\3-17-15(bag3-TUNEL)\bag3-homo-1\MD-Experiment-0003\MD-Experiment-0003_(c1+c3).JPG">
            <a:extLst>
              <a:ext uri="{FF2B5EF4-FFF2-40B4-BE49-F238E27FC236}">
                <a16:creationId xmlns:a16="http://schemas.microsoft.com/office/drawing/2014/main" id="{0247DE11-7245-9F13-F756-A6E6ABC1F3F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2000" contras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980" t="27927" r="36306" b="41627"/>
          <a:stretch>
            <a:fillRect/>
          </a:stretch>
        </p:blipFill>
        <p:spPr bwMode="auto">
          <a:xfrm rot="10800000">
            <a:off x="2040727" y="2270673"/>
            <a:ext cx="1253145" cy="10877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D43B207E-D41B-CF4A-BE01-24679DD50316}"/>
              </a:ext>
            </a:extLst>
          </p:cNvPr>
          <p:cNvCxnSpPr/>
          <p:nvPr/>
        </p:nvCxnSpPr>
        <p:spPr>
          <a:xfrm>
            <a:off x="5327254" y="3280502"/>
            <a:ext cx="35752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05812707-274C-3CCB-A3E2-5939ED062B21}"/>
              </a:ext>
            </a:extLst>
          </p:cNvPr>
          <p:cNvSpPr txBox="1"/>
          <p:nvPr/>
        </p:nvSpPr>
        <p:spPr>
          <a:xfrm>
            <a:off x="780601" y="1180373"/>
            <a:ext cx="5592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41DE9342-4FE6-211A-982E-8CB8DFF6A7F5}"/>
              </a:ext>
            </a:extLst>
          </p:cNvPr>
          <p:cNvSpPr txBox="1"/>
          <p:nvPr/>
        </p:nvSpPr>
        <p:spPr>
          <a:xfrm>
            <a:off x="750402" y="2255273"/>
            <a:ext cx="5592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UNEL</a:t>
            </a:r>
          </a:p>
          <a:p>
            <a:r>
              <a:rPr lang="en-US" sz="12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6EE2F901-1178-0270-0A1C-53074BEED2E4}"/>
              </a:ext>
            </a:extLst>
          </p:cNvPr>
          <p:cNvSpPr txBox="1"/>
          <p:nvPr/>
        </p:nvSpPr>
        <p:spPr>
          <a:xfrm>
            <a:off x="4460785" y="921652"/>
            <a:ext cx="14186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AD7C257-C27A-9760-0D7F-1F8AD85F9EBD}"/>
              </a:ext>
            </a:extLst>
          </p:cNvPr>
          <p:cNvSpPr txBox="1"/>
          <p:nvPr/>
        </p:nvSpPr>
        <p:spPr>
          <a:xfrm>
            <a:off x="1178405" y="922185"/>
            <a:ext cx="4584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EF462DA-3FAD-016D-C7EC-CE599BBC745F}"/>
              </a:ext>
            </a:extLst>
          </p:cNvPr>
          <p:cNvSpPr txBox="1"/>
          <p:nvPr/>
        </p:nvSpPr>
        <p:spPr>
          <a:xfrm>
            <a:off x="2202839" y="914669"/>
            <a:ext cx="9028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280998A-54AD-2918-A543-2801A81BD785}"/>
              </a:ext>
            </a:extLst>
          </p:cNvPr>
          <p:cNvSpPr txBox="1"/>
          <p:nvPr/>
        </p:nvSpPr>
        <p:spPr>
          <a:xfrm>
            <a:off x="3497583" y="911937"/>
            <a:ext cx="8671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9D9CE66C-3574-E2FE-0864-CA6FD83CD454}"/>
              </a:ext>
            </a:extLst>
          </p:cNvPr>
          <p:cNvCxnSpPr/>
          <p:nvPr/>
        </p:nvCxnSpPr>
        <p:spPr>
          <a:xfrm flipH="1" flipV="1">
            <a:off x="4684146" y="1277885"/>
            <a:ext cx="75620" cy="13435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EF9CA494-775C-9115-DC97-E18E4AD23B21}"/>
              </a:ext>
            </a:extLst>
          </p:cNvPr>
          <p:cNvCxnSpPr/>
          <p:nvPr/>
        </p:nvCxnSpPr>
        <p:spPr>
          <a:xfrm flipH="1" flipV="1">
            <a:off x="2094386" y="1736153"/>
            <a:ext cx="123867" cy="11101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6EE3820A-CD41-9919-3438-6D6AB2DBA79F}"/>
              </a:ext>
            </a:extLst>
          </p:cNvPr>
          <p:cNvCxnSpPr/>
          <p:nvPr/>
        </p:nvCxnSpPr>
        <p:spPr>
          <a:xfrm flipH="1" flipV="1">
            <a:off x="2250965" y="1336227"/>
            <a:ext cx="123867" cy="11101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>
            <a:extLst>
              <a:ext uri="{FF2B5EF4-FFF2-40B4-BE49-F238E27FC236}">
                <a16:creationId xmlns:a16="http://schemas.microsoft.com/office/drawing/2014/main" id="{713982B4-806D-0EF0-A214-A560C1DE7524}"/>
              </a:ext>
            </a:extLst>
          </p:cNvPr>
          <p:cNvCxnSpPr/>
          <p:nvPr/>
        </p:nvCxnSpPr>
        <p:spPr>
          <a:xfrm flipH="1" flipV="1">
            <a:off x="2095637" y="2028331"/>
            <a:ext cx="123867" cy="111018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>
            <a:extLst>
              <a:ext uri="{FF2B5EF4-FFF2-40B4-BE49-F238E27FC236}">
                <a16:creationId xmlns:a16="http://schemas.microsoft.com/office/drawing/2014/main" id="{B02DB038-15E5-122F-9936-5B316734D673}"/>
              </a:ext>
            </a:extLst>
          </p:cNvPr>
          <p:cNvCxnSpPr>
            <a:cxnSpLocks/>
          </p:cNvCxnSpPr>
          <p:nvPr/>
        </p:nvCxnSpPr>
        <p:spPr>
          <a:xfrm flipV="1">
            <a:off x="2446759" y="1368976"/>
            <a:ext cx="108148" cy="119962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Arrow Connector 116">
            <a:extLst>
              <a:ext uri="{FF2B5EF4-FFF2-40B4-BE49-F238E27FC236}">
                <a16:creationId xmlns:a16="http://schemas.microsoft.com/office/drawing/2014/main" id="{A27F7A68-7DF5-B5AE-883F-F8A57DDB42FB}"/>
              </a:ext>
            </a:extLst>
          </p:cNvPr>
          <p:cNvCxnSpPr>
            <a:cxnSpLocks/>
          </p:cNvCxnSpPr>
          <p:nvPr/>
        </p:nvCxnSpPr>
        <p:spPr>
          <a:xfrm flipV="1">
            <a:off x="2737320" y="1469952"/>
            <a:ext cx="108148" cy="119962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Straight Arrow Connector 117">
            <a:extLst>
              <a:ext uri="{FF2B5EF4-FFF2-40B4-BE49-F238E27FC236}">
                <a16:creationId xmlns:a16="http://schemas.microsoft.com/office/drawing/2014/main" id="{D2EA0187-8FD6-F0DC-5659-3F15E119311D}"/>
              </a:ext>
            </a:extLst>
          </p:cNvPr>
          <p:cNvCxnSpPr>
            <a:cxnSpLocks/>
          </p:cNvCxnSpPr>
          <p:nvPr/>
        </p:nvCxnSpPr>
        <p:spPr>
          <a:xfrm flipV="1">
            <a:off x="2870861" y="1612496"/>
            <a:ext cx="108148" cy="119962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Straight Arrow Connector 118">
            <a:extLst>
              <a:ext uri="{FF2B5EF4-FFF2-40B4-BE49-F238E27FC236}">
                <a16:creationId xmlns:a16="http://schemas.microsoft.com/office/drawing/2014/main" id="{8C429039-27DD-0A06-25D2-9B1F89DD42CC}"/>
              </a:ext>
            </a:extLst>
          </p:cNvPr>
          <p:cNvCxnSpPr>
            <a:cxnSpLocks/>
          </p:cNvCxnSpPr>
          <p:nvPr/>
        </p:nvCxnSpPr>
        <p:spPr>
          <a:xfrm flipV="1">
            <a:off x="2944424" y="1665724"/>
            <a:ext cx="108148" cy="119962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Arrow Connector 120">
            <a:extLst>
              <a:ext uri="{FF2B5EF4-FFF2-40B4-BE49-F238E27FC236}">
                <a16:creationId xmlns:a16="http://schemas.microsoft.com/office/drawing/2014/main" id="{02A1A033-3742-599D-7ACE-A8F3A341268D}"/>
              </a:ext>
            </a:extLst>
          </p:cNvPr>
          <p:cNvCxnSpPr>
            <a:cxnSpLocks/>
          </p:cNvCxnSpPr>
          <p:nvPr/>
        </p:nvCxnSpPr>
        <p:spPr>
          <a:xfrm flipV="1">
            <a:off x="5234697" y="1462058"/>
            <a:ext cx="108148" cy="119962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28B3E985-3043-4511-2C3F-0FD944BFA2A6}"/>
              </a:ext>
            </a:extLst>
          </p:cNvPr>
          <p:cNvCxnSpPr>
            <a:cxnSpLocks/>
          </p:cNvCxnSpPr>
          <p:nvPr/>
        </p:nvCxnSpPr>
        <p:spPr>
          <a:xfrm>
            <a:off x="4852109" y="2072808"/>
            <a:ext cx="176752" cy="78493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A graph with red lines and black text&#10;&#10;AI-generated content may be incorrect.">
            <a:extLst>
              <a:ext uri="{FF2B5EF4-FFF2-40B4-BE49-F238E27FC236}">
                <a16:creationId xmlns:a16="http://schemas.microsoft.com/office/drawing/2014/main" id="{6745AEC2-AA66-BBED-220F-44491B91E021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96" t="11144" r="7915" b="33739"/>
          <a:stretch>
            <a:fillRect/>
          </a:stretch>
        </p:blipFill>
        <p:spPr>
          <a:xfrm>
            <a:off x="1317256" y="3822743"/>
            <a:ext cx="1891811" cy="147483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4F385AC-6D4A-7C9C-FC32-28A69507B2C0}"/>
              </a:ext>
            </a:extLst>
          </p:cNvPr>
          <p:cNvSpPr txBox="1"/>
          <p:nvPr/>
        </p:nvSpPr>
        <p:spPr>
          <a:xfrm rot="16200000">
            <a:off x="14344" y="4364837"/>
            <a:ext cx="20874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s of TUNEL positive nuclei/section area 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453EDA07-B6C8-239F-EEDF-750D335FFE13}"/>
              </a:ext>
            </a:extLst>
          </p:cNvPr>
          <p:cNvSpPr txBox="1"/>
          <p:nvPr/>
        </p:nvSpPr>
        <p:spPr>
          <a:xfrm rot="18932373">
            <a:off x="2390976" y="5387549"/>
            <a:ext cx="860727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AD7844A-67A0-41CD-8DB7-FD6CE7C32A70}"/>
              </a:ext>
            </a:extLst>
          </p:cNvPr>
          <p:cNvSpPr txBox="1"/>
          <p:nvPr/>
        </p:nvSpPr>
        <p:spPr>
          <a:xfrm rot="18932373">
            <a:off x="1880899" y="5456156"/>
            <a:ext cx="8607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FD759B7-3A5A-91E3-C096-69F6AB3761C2}"/>
              </a:ext>
            </a:extLst>
          </p:cNvPr>
          <p:cNvSpPr txBox="1"/>
          <p:nvPr/>
        </p:nvSpPr>
        <p:spPr>
          <a:xfrm rot="18932373">
            <a:off x="1554770" y="5387344"/>
            <a:ext cx="8607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139BB392-0AB8-4226-5799-E907298AA6E7}"/>
              </a:ext>
            </a:extLst>
          </p:cNvPr>
          <p:cNvSpPr txBox="1"/>
          <p:nvPr/>
        </p:nvSpPr>
        <p:spPr>
          <a:xfrm rot="18932373">
            <a:off x="1457320" y="5283312"/>
            <a:ext cx="4641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EBC597D-C354-E86E-17B5-39E883D6AA6F}"/>
              </a:ext>
            </a:extLst>
          </p:cNvPr>
          <p:cNvSpPr txBox="1"/>
          <p:nvPr/>
        </p:nvSpPr>
        <p:spPr>
          <a:xfrm>
            <a:off x="470449" y="83959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637E74BB-5540-840D-A92B-0772744B50EE}"/>
              </a:ext>
            </a:extLst>
          </p:cNvPr>
          <p:cNvCxnSpPr>
            <a:cxnSpLocks/>
          </p:cNvCxnSpPr>
          <p:nvPr/>
        </p:nvCxnSpPr>
        <p:spPr>
          <a:xfrm>
            <a:off x="2094758" y="3919857"/>
            <a:ext cx="76997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2669B6EB-8CBF-C496-1E58-B2E366182B1D}"/>
              </a:ext>
            </a:extLst>
          </p:cNvPr>
          <p:cNvSpPr txBox="1"/>
          <p:nvPr/>
        </p:nvSpPr>
        <p:spPr>
          <a:xfrm>
            <a:off x="1550758" y="3935979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11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8A6B67E3-4D5A-784C-D45B-200A2BCBB65D}"/>
              </a:ext>
            </a:extLst>
          </p:cNvPr>
          <p:cNvCxnSpPr>
            <a:cxnSpLocks/>
          </p:cNvCxnSpPr>
          <p:nvPr/>
        </p:nvCxnSpPr>
        <p:spPr>
          <a:xfrm>
            <a:off x="1746359" y="4165561"/>
            <a:ext cx="315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21692DF8-8912-FF31-5271-AE73FAB29DF4}"/>
              </a:ext>
            </a:extLst>
          </p:cNvPr>
          <p:cNvSpPr txBox="1"/>
          <p:nvPr/>
        </p:nvSpPr>
        <p:spPr>
          <a:xfrm>
            <a:off x="2144997" y="3691865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5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4C5EE6C-511D-AC20-6AE0-B845C393AE74}"/>
              </a:ext>
            </a:extLst>
          </p:cNvPr>
          <p:cNvSpPr txBox="1"/>
          <p:nvPr/>
        </p:nvSpPr>
        <p:spPr>
          <a:xfrm>
            <a:off x="103368" y="5992748"/>
            <a:ext cx="672866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-B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epresentative images of the TUNEL assay (A) and quantification of TUNEL-positive nuclei (B) number in cardiac tissue sections of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;fabp7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uble mutants,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 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single mutants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, fabp7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ngle mutants, and WT control fish at 6 months of age. Arrows indicate TUNEL-</a:t>
            </a:r>
            <a:r>
              <a:rPr lang="en-US" altLang="ko-KR" sz="1200" dirty="0">
                <a:latin typeface="Arial" panose="020B0604020202020204" pitchFamily="34" charset="0"/>
                <a:cs typeface="Arial" panose="020B0604020202020204" pitchFamily="34" charset="0"/>
              </a:rPr>
              <a:t> positiv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ignals. Scale bar, 100 µm. n=3, one-way ANOVA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oteasome activity was significantly reduced 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mutant hearts and partially restored in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;fabp7a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uble mutant hearts. n=4, one-way ANOVA.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B7C2D2D-7E01-B769-246F-4AF54D4C2523}"/>
              </a:ext>
            </a:extLst>
          </p:cNvPr>
          <p:cNvSpPr txBox="1"/>
          <p:nvPr/>
        </p:nvSpPr>
        <p:spPr>
          <a:xfrm>
            <a:off x="58593" y="277883"/>
            <a:ext cx="67286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4. </a:t>
            </a:r>
            <a:r>
              <a:rPr lang="en-US" sz="1200" b="1" i="1" dirty="0">
                <a:latin typeface="Arial" panose="020B0604020202020204" pitchFamily="34" charset="0"/>
                <a:ea typeface="SimSun" panose="02010600030101010101" pitchFamily="2" charset="-122"/>
              </a:rPr>
              <a:t>fabp7a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</a:rPr>
              <a:t> inhibition reduces the apoptosis index and enhances proteasome activity in the </a:t>
            </a:r>
            <a:r>
              <a:rPr lang="en-US" sz="1200" b="1" i="1" dirty="0">
                <a:latin typeface="Arial" panose="020B0604020202020204" pitchFamily="34" charset="0"/>
                <a:ea typeface="SimSun" panose="02010600030101010101" pitchFamily="2" charset="-122"/>
              </a:rPr>
              <a:t>bag3</a:t>
            </a:r>
            <a:r>
              <a:rPr lang="en-US" sz="1200" b="1" dirty="0">
                <a:latin typeface="Arial" panose="020B0604020202020204" pitchFamily="34" charset="0"/>
                <a:ea typeface="SimSun" panose="02010600030101010101" pitchFamily="2" charset="-122"/>
              </a:rPr>
              <a:t> cardiomyopathy model</a:t>
            </a:r>
            <a:endParaRPr lang="en-US" sz="1200" dirty="0"/>
          </a:p>
        </p:txBody>
      </p:sp>
      <p:pic>
        <p:nvPicPr>
          <p:cNvPr id="54" name="Picture 53" descr="A graph of a number of objects&#10;&#10;AI-generated content may be incorrect.">
            <a:extLst>
              <a:ext uri="{FF2B5EF4-FFF2-40B4-BE49-F238E27FC236}">
                <a16:creationId xmlns:a16="http://schemas.microsoft.com/office/drawing/2014/main" id="{666800DF-F930-55DD-105E-B7D0BE80BA9A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77" t="11656" r="5206" b="32045"/>
          <a:stretch>
            <a:fillRect/>
          </a:stretch>
        </p:blipFill>
        <p:spPr>
          <a:xfrm>
            <a:off x="3814851" y="3845892"/>
            <a:ext cx="1756442" cy="1481241"/>
          </a:xfrm>
          <a:prstGeom prst="rect">
            <a:avLst/>
          </a:prstGeom>
        </p:spPr>
      </p:pic>
      <p:sp>
        <p:nvSpPr>
          <p:cNvPr id="65" name="TextBox 64">
            <a:extLst>
              <a:ext uri="{FF2B5EF4-FFF2-40B4-BE49-F238E27FC236}">
                <a16:creationId xmlns:a16="http://schemas.microsoft.com/office/drawing/2014/main" id="{13A53F68-0A97-0EC7-056B-5F7492EF1E47}"/>
              </a:ext>
            </a:extLst>
          </p:cNvPr>
          <p:cNvSpPr txBox="1"/>
          <p:nvPr/>
        </p:nvSpPr>
        <p:spPr>
          <a:xfrm rot="16200000">
            <a:off x="2525252" y="4472134"/>
            <a:ext cx="2286000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100" b="0" i="0" dirty="0">
                <a:solidFill>
                  <a:srgbClr val="001D35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elative Fluorescence Units</a:t>
            </a:r>
          </a:p>
          <a:p>
            <a:pPr algn="ctr"/>
            <a:r>
              <a:rPr lang="en-US" sz="1100" b="0" i="0" dirty="0">
                <a:solidFill>
                  <a:srgbClr val="001D35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(RFU) per hour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1DEDBC6-3005-8481-5C07-D6588DE5B2D3}"/>
              </a:ext>
            </a:extLst>
          </p:cNvPr>
          <p:cNvSpPr txBox="1"/>
          <p:nvPr/>
        </p:nvSpPr>
        <p:spPr>
          <a:xfrm rot="18932373">
            <a:off x="4779690" y="5332776"/>
            <a:ext cx="91507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;</a:t>
            </a:r>
          </a:p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BA7384AD-9480-49E7-236C-2953A3596026}"/>
              </a:ext>
            </a:extLst>
          </p:cNvPr>
          <p:cNvSpPr txBox="1"/>
          <p:nvPr/>
        </p:nvSpPr>
        <p:spPr>
          <a:xfrm rot="18932373">
            <a:off x="4301364" y="5390956"/>
            <a:ext cx="93620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fabp7a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1/+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A1A18415-0FE4-151F-E4A1-3A7EAABF31CC}"/>
              </a:ext>
            </a:extLst>
          </p:cNvPr>
          <p:cNvSpPr txBox="1"/>
          <p:nvPr/>
        </p:nvSpPr>
        <p:spPr>
          <a:xfrm rot="18932373">
            <a:off x="4061267" y="5363512"/>
            <a:ext cx="792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bag3</a:t>
            </a:r>
            <a:r>
              <a:rPr lang="en-US" sz="11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e2/e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AA6C8C1-21B9-0DE7-DE4D-582C1B0ED67B}"/>
              </a:ext>
            </a:extLst>
          </p:cNvPr>
          <p:cNvSpPr txBox="1"/>
          <p:nvPr/>
        </p:nvSpPr>
        <p:spPr>
          <a:xfrm rot="18932373">
            <a:off x="4004357" y="5278664"/>
            <a:ext cx="4274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en-US" sz="11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909B540-576C-F10D-422A-40D8A6741B5D}"/>
              </a:ext>
            </a:extLst>
          </p:cNvPr>
          <p:cNvSpPr txBox="1"/>
          <p:nvPr/>
        </p:nvSpPr>
        <p:spPr>
          <a:xfrm>
            <a:off x="3286995" y="350733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0E4BD39D-EFBF-94E1-19DC-D2CAD4AED821}"/>
              </a:ext>
            </a:extLst>
          </p:cNvPr>
          <p:cNvSpPr txBox="1"/>
          <p:nvPr/>
        </p:nvSpPr>
        <p:spPr>
          <a:xfrm>
            <a:off x="4065163" y="3573272"/>
            <a:ext cx="152227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roteasome activity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CAF936F4-723D-14D3-A745-346EDBABDD40}"/>
              </a:ext>
            </a:extLst>
          </p:cNvPr>
          <p:cNvCxnSpPr>
            <a:cxnSpLocks/>
          </p:cNvCxnSpPr>
          <p:nvPr/>
        </p:nvCxnSpPr>
        <p:spPr>
          <a:xfrm>
            <a:off x="4605152" y="4038207"/>
            <a:ext cx="63059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AFB57461-9AFC-5C43-23D8-0C8D9508E57B}"/>
              </a:ext>
            </a:extLst>
          </p:cNvPr>
          <p:cNvSpPr txBox="1"/>
          <p:nvPr/>
        </p:nvSpPr>
        <p:spPr>
          <a:xfrm>
            <a:off x="4107233" y="4054217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&lt;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0.001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45610E1E-CEBA-FAD2-2FC2-C8CD1F275DEA}"/>
              </a:ext>
            </a:extLst>
          </p:cNvPr>
          <p:cNvCxnSpPr>
            <a:cxnSpLocks/>
          </p:cNvCxnSpPr>
          <p:nvPr/>
        </p:nvCxnSpPr>
        <p:spPr>
          <a:xfrm>
            <a:off x="4266688" y="4279987"/>
            <a:ext cx="31578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A741A21C-C97B-944C-C4DD-FEADF19FAB69}"/>
              </a:ext>
            </a:extLst>
          </p:cNvPr>
          <p:cNvSpPr txBox="1"/>
          <p:nvPr/>
        </p:nvSpPr>
        <p:spPr>
          <a:xfrm>
            <a:off x="4558524" y="3817120"/>
            <a:ext cx="7136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=0.001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5E1FCB31-E60D-0162-6B61-4A22869537FB}"/>
              </a:ext>
            </a:extLst>
          </p:cNvPr>
          <p:cNvSpPr txBox="1"/>
          <p:nvPr/>
        </p:nvSpPr>
        <p:spPr>
          <a:xfrm>
            <a:off x="536531" y="350733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8368632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Tab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91012059"/>
              </p:ext>
            </p:extLst>
          </p:nvPr>
        </p:nvGraphicFramePr>
        <p:xfrm>
          <a:off x="127593" y="1031354"/>
          <a:ext cx="6549655" cy="3587421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176380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97885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0397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60302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2130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3" marR="7663" marT="1362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cu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63" marR="7663" marT="1362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i="1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tor</a:t>
                      </a:r>
                      <a:r>
                        <a:rPr lang="en-US" sz="1200" i="1" u="none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u015</a:t>
                      </a:r>
                      <a:r>
                        <a:rPr lang="en-US" sz="1200" u="none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+ </a:t>
                      </a:r>
                      <a:r>
                        <a:rPr lang="en-US" sz="1200" u="none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 WT</a:t>
                      </a:r>
                    </a:p>
                    <a:p>
                      <a:pPr algn="ctr" fontAlgn="b"/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2(FC)</a:t>
                      </a:r>
                    </a:p>
                  </a:txBody>
                  <a:tcPr marL="7663" marR="7663" marT="1362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i="1" u="none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</a:t>
                      </a:r>
                      <a:r>
                        <a:rPr lang="en-US" sz="1200" i="1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mlc2-tfeb)</a:t>
                      </a:r>
                      <a:r>
                        <a:rPr lang="en-US" sz="1200" u="none" baseline="30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200" u="none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s WT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g2(FC)</a:t>
                      </a:r>
                    </a:p>
                  </a:txBody>
                  <a:tcPr marL="7663" marR="7663" marT="13623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cl2l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4:6165398-618195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90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tnl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4:14938412-1495415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abp7a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7:15274756-1527712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krd9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7:29335653-2933684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4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090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:dkey-238c7.13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8:7047760-705066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cnj5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8:47136468-4720749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dn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9:3938958-394417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SDARG00000020455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9:11036022-1104800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9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n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9:41146726-411658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el</a:t>
                      </a:r>
                      <a:r>
                        <a:rPr lang="en-US" sz="1200" i="1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ene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19:18031738-1803215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4.2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YADM (1 of 2)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2:37470848-3748007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pz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2:44320982-4434452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IDEC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6:22886995-2289642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.7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09074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vel</a:t>
                      </a:r>
                      <a:r>
                        <a:rPr lang="en-US" sz="1200" i="1" u="none" strike="noStrike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gene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7:53207421-5321237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.3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5068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BZ01079442.1</a:t>
                      </a:r>
                      <a:endParaRPr lang="en-US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r9:5289139-533027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.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607" marR="5607" marT="9968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.6</a:t>
                      </a:r>
                    </a:p>
                  </a:txBody>
                  <a:tcPr marL="9525" marR="9525" marT="9525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  <p:sp>
        <p:nvSpPr>
          <p:cNvPr id="15" name="TextBox 14"/>
          <p:cNvSpPr txBox="1"/>
          <p:nvPr/>
        </p:nvSpPr>
        <p:spPr>
          <a:xfrm>
            <a:off x="74428" y="301797"/>
            <a:ext cx="65610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ist of 15 overlapping genes downregulated in both the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r>
              <a:rPr lang="en-US" sz="1200" i="1" baseline="30000" dirty="0">
                <a:latin typeface="Arial" panose="020B0604020202020204" pitchFamily="34" charset="0"/>
                <a:cs typeface="Arial" panose="020B0604020202020204" pitchFamily="34" charset="0"/>
              </a:rPr>
              <a:t>xu015/+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haploinsufficiency mutant 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Tg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(cmlc2-tfe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ransgenic hearts</a:t>
            </a:r>
            <a:endParaRPr lang="en-U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278245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82</TotalTime>
  <Words>890</Words>
  <Application>Microsoft Office PowerPoint</Application>
  <PresentationFormat>On-screen Show (4:3)</PresentationFormat>
  <Paragraphs>229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u, Xiaolei, Ph.D.</dc:creator>
  <cp:lastModifiedBy>Ding, Yonghe, Ph.D.</cp:lastModifiedBy>
  <cp:revision>598</cp:revision>
  <cp:lastPrinted>2024-04-12T18:31:19Z</cp:lastPrinted>
  <dcterms:created xsi:type="dcterms:W3CDTF">2021-08-27T16:41:06Z</dcterms:created>
  <dcterms:modified xsi:type="dcterms:W3CDTF">2025-08-13T17:47:31Z</dcterms:modified>
</cp:coreProperties>
</file>